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2A3198D-AC0E-4459-93BC-3C0CFD08E36F}"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14DD972-7179-428D-BAFC-44324C340D7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B3AF6AC-846D-4D7B-A240-FA751DBFF6E1}"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B2E2203B-EA4F-4540-BFB4-CAB98A55BC54}"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4F9D91C-A059-4F25-A8F8-0E317B6AF94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31C084B-E20F-4DC2-AB45-91C5E7810E3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845160F-FF6F-4E45-B2A6-E6927297756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B45070F-D99D-4370-9697-6D354BB153D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A4033A9-104E-4F5E-A6E3-FC81E148A6E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60D981F-BD7F-4F8C-AD6D-7E78E107895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5461334-1D71-4891-9BC3-C3FB3559DD8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35AA54A-41B6-4DD4-90B0-AD6A9C1A626F}"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AE4DEC6-E7EA-490C-865F-B6A3D4869A8B}"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1" name="Picture 3" descr=""/>
          <p:cNvPicPr/>
          <p:nvPr/>
        </p:nvPicPr>
        <p:blipFill>
          <a:blip r:embed="rId1"/>
          <a:stretch/>
        </p:blipFill>
        <p:spPr>
          <a:xfrm>
            <a:off x="1187280" y="476280"/>
            <a:ext cx="6121440" cy="4405320"/>
          </a:xfrm>
          <a:prstGeom prst="rect">
            <a:avLst/>
          </a:prstGeom>
          <a:ln w="0">
            <a:noFill/>
          </a:ln>
        </p:spPr>
      </p:pic>
      <p:sp>
        <p:nvSpPr>
          <p:cNvPr id="42" name=""/>
          <p:cNvSpPr/>
          <p:nvPr/>
        </p:nvSpPr>
        <p:spPr>
          <a:xfrm>
            <a:off x="468360" y="5203800"/>
            <a:ext cx="8280360" cy="641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Additional file 6</a:t>
            </a:r>
            <a:r>
              <a:rPr b="0" lang="en-US" sz="1200" spc="-1" strike="noStrike">
                <a:solidFill>
                  <a:srgbClr val="000000"/>
                </a:solidFill>
                <a:latin typeface="Times New Roman"/>
              </a:rPr>
              <a:t>. Comparative diagram of the total number of up-, down-regulated genes and common regulated genes between leave and root at tillering stage (TL, TR), leave and root at panicle elongation stage (PL, PR), leave and panicle at booting stage (BL, BP) under drought stress.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06-15T08:39:26Z</dcterms:created>
  <dc:creator>Binying Fu</dc:creator>
  <dc:description/>
  <dc:language>en-US</dc:language>
  <cp:lastModifiedBy>Binying Fu</cp:lastModifiedBy>
  <dcterms:modified xsi:type="dcterms:W3CDTF">2011-03-09T06:14:51Z</dcterms:modified>
  <cp:revision>4</cp:revision>
  <dc:subject/>
  <dc:title>幻灯片 1</dc:title>
</cp:coreProperties>
</file>